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1236" y="240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ADCDE8-4774-4A89-B1A8-5C9454BC8DDE}" type="datetimeFigureOut">
              <a:rPr lang="en-GB" smtClean="0"/>
              <a:t>06/09/2014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4BADE-152D-48E3-88DF-6CCA9E5EE17C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113520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ADCDE8-4774-4A89-B1A8-5C9454BC8DDE}" type="datetimeFigureOut">
              <a:rPr lang="en-GB" smtClean="0"/>
              <a:t>06/09/2014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4BADE-152D-48E3-88DF-6CCA9E5EE17C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266039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ADCDE8-4774-4A89-B1A8-5C9454BC8DDE}" type="datetimeFigureOut">
              <a:rPr lang="en-GB" smtClean="0"/>
              <a:t>06/09/2014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4BADE-152D-48E3-88DF-6CCA9E5EE17C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72270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ADCDE8-4774-4A89-B1A8-5C9454BC8DDE}" type="datetimeFigureOut">
              <a:rPr lang="en-GB" smtClean="0"/>
              <a:t>06/09/2014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4BADE-152D-48E3-88DF-6CCA9E5EE17C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425730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ADCDE8-4774-4A89-B1A8-5C9454BC8DDE}" type="datetimeFigureOut">
              <a:rPr lang="en-GB" smtClean="0"/>
              <a:t>06/09/2014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4BADE-152D-48E3-88DF-6CCA9E5EE17C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063501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ADCDE8-4774-4A89-B1A8-5C9454BC8DDE}" type="datetimeFigureOut">
              <a:rPr lang="en-GB" smtClean="0"/>
              <a:t>06/09/2014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4BADE-152D-48E3-88DF-6CCA9E5EE17C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152370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ADCDE8-4774-4A89-B1A8-5C9454BC8DDE}" type="datetimeFigureOut">
              <a:rPr lang="en-GB" smtClean="0"/>
              <a:t>06/09/2014</a:t>
            </a:fld>
            <a:endParaRPr lang="en-GB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4BADE-152D-48E3-88DF-6CCA9E5EE17C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09219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ADCDE8-4774-4A89-B1A8-5C9454BC8DDE}" type="datetimeFigureOut">
              <a:rPr lang="en-GB" smtClean="0"/>
              <a:t>06/09/2014</a:t>
            </a:fld>
            <a:endParaRPr lang="en-GB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4BADE-152D-48E3-88DF-6CCA9E5EE17C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140962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ADCDE8-4774-4A89-B1A8-5C9454BC8DDE}" type="datetimeFigureOut">
              <a:rPr lang="en-GB" smtClean="0"/>
              <a:t>06/09/2014</a:t>
            </a:fld>
            <a:endParaRPr lang="en-GB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4BADE-152D-48E3-88DF-6CCA9E5EE17C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698139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ADCDE8-4774-4A89-B1A8-5C9454BC8DDE}" type="datetimeFigureOut">
              <a:rPr lang="en-GB" smtClean="0"/>
              <a:t>06/09/2014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4BADE-152D-48E3-88DF-6CCA9E5EE17C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209419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ADCDE8-4774-4A89-B1A8-5C9454BC8DDE}" type="datetimeFigureOut">
              <a:rPr lang="en-GB" smtClean="0"/>
              <a:t>06/09/2014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4BADE-152D-48E3-88DF-6CCA9E5EE17C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526507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ADCDE8-4774-4A89-B1A8-5C9454BC8DDE}" type="datetimeFigureOut">
              <a:rPr lang="en-GB" smtClean="0"/>
              <a:t>06/09/2014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94BADE-152D-48E3-88DF-6CCA9E5EE17C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93093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20078" y="136109"/>
            <a:ext cx="22236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err="1" smtClean="0">
                <a:latin typeface="Arial" pitchFamily="34" charset="0"/>
                <a:cs typeface="Arial" pitchFamily="34" charset="0"/>
              </a:rPr>
              <a:t>Supplementary</a:t>
            </a:r>
            <a:r>
              <a:rPr lang="de-DE" sz="14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400" b="1" dirty="0" err="1" smtClean="0">
                <a:latin typeface="Arial" pitchFamily="34" charset="0"/>
                <a:cs typeface="Arial" pitchFamily="34" charset="0"/>
              </a:rPr>
              <a:t>Figure</a:t>
            </a:r>
            <a:r>
              <a:rPr lang="de-DE" sz="14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400" b="1" dirty="0">
                <a:latin typeface="Arial" pitchFamily="34" charset="0"/>
                <a:cs typeface="Arial" pitchFamily="34" charset="0"/>
              </a:rPr>
              <a:t>2</a:t>
            </a:r>
          </a:p>
        </p:txBody>
      </p:sp>
      <p:sp>
        <p:nvSpPr>
          <p:cNvPr id="5" name="Textfeld 4"/>
          <p:cNvSpPr txBox="1"/>
          <p:nvPr/>
        </p:nvSpPr>
        <p:spPr>
          <a:xfrm>
            <a:off x="116632" y="446646"/>
            <a:ext cx="554799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err="1" smtClean="0">
                <a:latin typeface="Arial" pitchFamily="34" charset="0"/>
                <a:cs typeface="Arial" pitchFamily="34" charset="0"/>
              </a:rPr>
              <a:t>Effects</a:t>
            </a:r>
            <a:r>
              <a:rPr lang="de-DE" sz="1400" dirty="0" smtClean="0">
                <a:latin typeface="Arial" pitchFamily="34" charset="0"/>
                <a:cs typeface="Arial" pitchFamily="34" charset="0"/>
              </a:rPr>
              <a:t> on VEGF-A </a:t>
            </a:r>
            <a:r>
              <a:rPr lang="de-DE" sz="1400" dirty="0" err="1" smtClean="0">
                <a:latin typeface="Arial" pitchFamily="34" charset="0"/>
                <a:cs typeface="Arial" pitchFamily="34" charset="0"/>
              </a:rPr>
              <a:t>and</a:t>
            </a:r>
            <a:r>
              <a:rPr lang="de-DE" sz="1400" dirty="0" smtClean="0">
                <a:latin typeface="Arial" pitchFamily="34" charset="0"/>
                <a:cs typeface="Arial" pitchFamily="34" charset="0"/>
              </a:rPr>
              <a:t> PDGF-B </a:t>
            </a:r>
            <a:r>
              <a:rPr lang="de-DE" sz="1400" dirty="0" err="1" smtClean="0">
                <a:latin typeface="Arial" pitchFamily="34" charset="0"/>
                <a:cs typeface="Arial" pitchFamily="34" charset="0"/>
              </a:rPr>
              <a:t>secretion</a:t>
            </a:r>
            <a:r>
              <a:rPr lang="de-DE" sz="1400" dirty="0" smtClean="0">
                <a:latin typeface="Arial" pitchFamily="34" charset="0"/>
                <a:cs typeface="Arial" pitchFamily="34" charset="0"/>
              </a:rPr>
              <a:t> in </a:t>
            </a:r>
            <a:r>
              <a:rPr lang="de-DE" sz="1400" dirty="0" err="1" smtClean="0">
                <a:latin typeface="Arial" pitchFamily="34" charset="0"/>
                <a:cs typeface="Arial" pitchFamily="34" charset="0"/>
              </a:rPr>
              <a:t>pancreatic</a:t>
            </a:r>
            <a:r>
              <a:rPr lang="de-DE" sz="14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400" dirty="0" err="1" smtClean="0">
                <a:latin typeface="Arial" pitchFamily="34" charset="0"/>
                <a:cs typeface="Arial" pitchFamily="34" charset="0"/>
              </a:rPr>
              <a:t>cancer</a:t>
            </a:r>
            <a:r>
              <a:rPr lang="de-DE" sz="14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400" dirty="0" err="1" smtClean="0">
                <a:latin typeface="Arial" pitchFamily="34" charset="0"/>
                <a:cs typeface="Arial" pitchFamily="34" charset="0"/>
              </a:rPr>
              <a:t>cells</a:t>
            </a:r>
            <a:endParaRPr lang="de-DE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Textfeld 6"/>
          <p:cNvSpPr txBox="1"/>
          <p:nvPr/>
        </p:nvSpPr>
        <p:spPr>
          <a:xfrm>
            <a:off x="260648" y="962964"/>
            <a:ext cx="258488" cy="25965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b="1" dirty="0" smtClean="0">
                <a:latin typeface="Arial" pitchFamily="34" charset="0"/>
                <a:cs typeface="Arial" pitchFamily="34" charset="0"/>
              </a:rPr>
              <a:t>A</a:t>
            </a:r>
            <a:endParaRPr lang="de-DE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" name="Textfeld 19"/>
          <p:cNvSpPr txBox="1"/>
          <p:nvPr/>
        </p:nvSpPr>
        <p:spPr>
          <a:xfrm>
            <a:off x="3381749" y="918914"/>
            <a:ext cx="264105" cy="25799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b="1" dirty="0" smtClean="0">
                <a:latin typeface="Arial" pitchFamily="34" charset="0"/>
                <a:cs typeface="Arial" pitchFamily="34" charset="0"/>
              </a:rPr>
              <a:t>B</a:t>
            </a:r>
            <a:endParaRPr lang="de-DE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0" name="Textfeld 29"/>
          <p:cNvSpPr txBox="1"/>
          <p:nvPr/>
        </p:nvSpPr>
        <p:spPr>
          <a:xfrm>
            <a:off x="232513" y="3368823"/>
            <a:ext cx="249504" cy="27159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b="1" dirty="0" smtClean="0">
                <a:latin typeface="Arial" pitchFamily="34" charset="0"/>
                <a:cs typeface="Arial" pitchFamily="34" charset="0"/>
              </a:rPr>
              <a:t>C</a:t>
            </a:r>
            <a:endParaRPr lang="de-DE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9" name="Textfeld 38"/>
          <p:cNvSpPr txBox="1"/>
          <p:nvPr/>
        </p:nvSpPr>
        <p:spPr>
          <a:xfrm>
            <a:off x="3460346" y="3296816"/>
            <a:ext cx="261804" cy="27165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b="1" dirty="0" smtClean="0">
                <a:latin typeface="Arial" pitchFamily="34" charset="0"/>
                <a:cs typeface="Arial" pitchFamily="34" charset="0"/>
              </a:rPr>
              <a:t>D</a:t>
            </a:r>
            <a:endParaRPr lang="de-DE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9" name="Textfeld 58"/>
          <p:cNvSpPr txBox="1"/>
          <p:nvPr/>
        </p:nvSpPr>
        <p:spPr>
          <a:xfrm>
            <a:off x="332656" y="5457056"/>
            <a:ext cx="263133" cy="27482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b="1" dirty="0" smtClean="0">
                <a:latin typeface="Arial" pitchFamily="34" charset="0"/>
                <a:cs typeface="Arial" pitchFamily="34" charset="0"/>
              </a:rPr>
              <a:t>E</a:t>
            </a:r>
            <a:endParaRPr lang="de-DE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7" name="Rechteck 66"/>
          <p:cNvSpPr/>
          <p:nvPr/>
        </p:nvSpPr>
        <p:spPr>
          <a:xfrm>
            <a:off x="236234" y="7833320"/>
            <a:ext cx="6361118" cy="178510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Effects of targeting </a:t>
            </a:r>
            <a:r>
              <a:rPr lang="en-GB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cMET</a:t>
            </a: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on VEGF-A and PDGF-B secretion from cancer cells.</a:t>
            </a:r>
            <a:endParaRPr lang="en-GB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Hypoxia led to a significant increase in VEGF-A secretion from L3.6pl cancer cells (</a:t>
            </a:r>
            <a:r>
              <a:rPr lang="en-GB" sz="11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  <a:r>
              <a:rPr lang="en-GB" sz="11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&lt;0.05). INC280 did not affect this. </a:t>
            </a:r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Induction with DFX led to a significant increase in PDGF-B secretion from HPAF-II pancreatic cancer cells (</a:t>
            </a:r>
            <a:r>
              <a:rPr lang="en-GB" sz="11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  <a:r>
              <a:rPr lang="en-GB" sz="11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&lt;0.05). Targeting </a:t>
            </a:r>
            <a:r>
              <a:rPr lang="en-GB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MET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had no impact on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this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)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Similar, DFX led to increase in PDGF-B secretion from L3.6pl and INC280 did not reduce this </a:t>
            </a:r>
            <a:r>
              <a:rPr lang="en-GB" sz="1100" i="1" dirty="0" smtClean="0">
                <a:latin typeface="Arial" panose="020B0604020202020204" pitchFamily="34" charset="0"/>
                <a:cs typeface="Arial" panose="020B0604020202020204" pitchFamily="34" charset="0"/>
              </a:rPr>
              <a:t>in vitro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GB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  <a:r>
              <a:rPr lang="en-GB" sz="11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&lt;0.05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). </a:t>
            </a:r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)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Gemcitabine resistant MiaPaCa2(G250) showed a higher secretion of PDGF-B compared to regular MiaPaCa2(par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) (</a:t>
            </a:r>
            <a:r>
              <a:rPr lang="en-GB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  <a:r>
              <a:rPr lang="en-GB" sz="11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&lt;0.05). </a:t>
            </a:r>
            <a:r>
              <a:rPr lang="en-GB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MET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inhibition had no effect on this </a:t>
            </a:r>
            <a:r>
              <a:rPr lang="en-GB" sz="1100" i="1" dirty="0" smtClean="0">
                <a:latin typeface="Arial" panose="020B0604020202020204" pitchFamily="34" charset="0"/>
                <a:cs typeface="Arial" panose="020B0604020202020204" pitchFamily="34" charset="0"/>
              </a:rPr>
              <a:t>in vitro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)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Incubation with DFX led to a significant increase in PDGF-B secretion from MiaPaCa2(G250) but INC280 did not affect this increase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GB" sz="11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  <a:r>
              <a:rPr lang="en-GB" sz="11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&lt;0.05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). </a:t>
            </a:r>
            <a:r>
              <a:rPr lang="en-GB" sz="1100" smtClean="0">
                <a:latin typeface="Arial" panose="020B0604020202020204" pitchFamily="34" charset="0"/>
                <a:cs typeface="Arial" panose="020B0604020202020204" pitchFamily="34" charset="0"/>
              </a:rPr>
              <a:t>Bars=SE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3449" y="1064568"/>
            <a:ext cx="2908300" cy="20732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73016" y="1064568"/>
            <a:ext cx="2882900" cy="21637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4576" y="3504621"/>
            <a:ext cx="2779713" cy="20669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27890" y="3503827"/>
            <a:ext cx="2835275" cy="20970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9123" y="5814813"/>
            <a:ext cx="2878137" cy="20367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030373060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70</Words>
  <Application>Microsoft Office PowerPoint</Application>
  <PresentationFormat>A4-Papier (210x297 mm)</PresentationFormat>
  <Paragraphs>9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Company>Universität Regensburg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Sven Arke Lang</dc:creator>
  <cp:lastModifiedBy>Sven Arke Lang</cp:lastModifiedBy>
  <cp:revision>8</cp:revision>
  <dcterms:created xsi:type="dcterms:W3CDTF">2014-07-03T17:49:29Z</dcterms:created>
  <dcterms:modified xsi:type="dcterms:W3CDTF">2014-09-06T13:50:03Z</dcterms:modified>
</cp:coreProperties>
</file>